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7" r:id="rId2"/>
  </p:sldIdLst>
  <p:sldSz cx="9144000" cy="6858000" type="screen4x3"/>
  <p:notesSz cx="6858000" cy="9144000"/>
  <p:defaultTextStyle>
    <a:defPPr>
      <a:defRPr lang="th-TH"/>
    </a:defPPr>
    <a:lvl1pPr marL="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176"/>
    <p:restoredTop sz="92399"/>
  </p:normalViewPr>
  <p:slideViewPr>
    <p:cSldViewPr>
      <p:cViewPr varScale="1">
        <p:scale>
          <a:sx n="80" d="100"/>
          <a:sy n="80" d="100"/>
        </p:scale>
        <p:origin x="1958" y="-269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ตัวยึดหัวกระดาษ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th-TH"/>
          </a:p>
        </p:txBody>
      </p:sp>
      <p:sp>
        <p:nvSpPr>
          <p:cNvPr id="3" name="ตัวยึดวันที่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A218B4-F4EC-4F40-8DD3-E73489F7E371}" type="datetimeFigureOut">
              <a:rPr lang="th-TH" smtClean="0"/>
              <a:pPr/>
              <a:t>19/10/64</a:t>
            </a:fld>
            <a:endParaRPr lang="th-TH"/>
          </a:p>
        </p:txBody>
      </p:sp>
      <p:sp>
        <p:nvSpPr>
          <p:cNvPr id="4" name="ตัวยึดรูปบนภาพนิ่ง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th-TH"/>
          </a:p>
        </p:txBody>
      </p:sp>
      <p:sp>
        <p:nvSpPr>
          <p:cNvPr id="5" name="ตัวยึดบันทึกย่อ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h-TH"/>
              <a:t>คลิกเพื่อแก้ไขลักษณะ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6" name="ตัวยึดท้ายกระดา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th-TH"/>
          </a:p>
        </p:txBody>
      </p:sp>
      <p:sp>
        <p:nvSpPr>
          <p:cNvPr id="7" name="ตัวยึดหมายเลขภาพนิ่ง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4F68CCD-AAFC-48F5-90C5-23C50A7B29B4}" type="slidenum">
              <a:rPr lang="th-TH" smtClean="0"/>
              <a:pPr/>
              <a:t>‹#›</a:t>
            </a:fld>
            <a:endParaRPr lang="th-TH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ภาพนิ่ง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th-TH"/>
              <a:t>คลิกเพื่อแก้ไขลักษณะชื่อเรื่องต้นแบบ</a:t>
            </a:r>
          </a:p>
        </p:txBody>
      </p:sp>
      <p:sp>
        <p:nvSpPr>
          <p:cNvPr id="3" name="ชื่อเรื่องรอง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th-TH"/>
              <a:t>คลิกเพื่อแก้ไขลักษณะชื่อเรื่องรองต้นแบบ</a:t>
            </a:r>
          </a:p>
        </p:txBody>
      </p:sp>
      <p:sp>
        <p:nvSpPr>
          <p:cNvPr id="4" name="ตัวยึดวันที่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C7C2B-39D4-4C7E-AF8C-F2C3E9E03AE9}" type="datetimeFigureOut">
              <a:rPr lang="th-TH" smtClean="0"/>
              <a:pPr/>
              <a:t>19/10/64</a:t>
            </a:fld>
            <a:endParaRPr lang="th-TH"/>
          </a:p>
        </p:txBody>
      </p:sp>
      <p:sp>
        <p:nvSpPr>
          <p:cNvPr id="5" name="ตัวยึดท้ายกระดา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ยึดหมายเลขภาพนิ่ง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25DF7-5D81-48FB-88EB-F3941DF12C23}" type="slidenum">
              <a:rPr lang="th-TH" smtClean="0"/>
              <a:pPr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ชื่อเรื่องและข้อความ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ลักษณะชื่อเรื่องต้นแบบ</a:t>
            </a:r>
          </a:p>
        </p:txBody>
      </p:sp>
      <p:sp>
        <p:nvSpPr>
          <p:cNvPr id="3" name="ตัวยึดข้อความแนวตั้ง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h-TH"/>
              <a:t>คลิกเพื่อแก้ไขลักษณะ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ยึดวันที่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C7C2B-39D4-4C7E-AF8C-F2C3E9E03AE9}" type="datetimeFigureOut">
              <a:rPr lang="th-TH" smtClean="0"/>
              <a:pPr/>
              <a:t>19/10/64</a:t>
            </a:fld>
            <a:endParaRPr lang="th-TH"/>
          </a:p>
        </p:txBody>
      </p:sp>
      <p:sp>
        <p:nvSpPr>
          <p:cNvPr id="5" name="ตัวยึดท้ายกระดา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ยึดหมายเลขภาพนิ่ง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25DF7-5D81-48FB-88EB-F3941DF12C23}" type="slidenum">
              <a:rPr lang="th-TH" smtClean="0"/>
              <a:pPr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ข้อความและชื่อเรื่อง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แนวตั้ง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th-TH"/>
              <a:t>คลิกเพื่อแก้ไขลักษณะชื่อเรื่องต้นแบบ</a:t>
            </a:r>
          </a:p>
        </p:txBody>
      </p:sp>
      <p:sp>
        <p:nvSpPr>
          <p:cNvPr id="3" name="ตัวยึดข้อความแนวตั้ง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th-TH"/>
              <a:t>คลิกเพื่อแก้ไขลักษณะ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ยึดวันที่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C7C2B-39D4-4C7E-AF8C-F2C3E9E03AE9}" type="datetimeFigureOut">
              <a:rPr lang="th-TH" smtClean="0"/>
              <a:pPr/>
              <a:t>19/10/64</a:t>
            </a:fld>
            <a:endParaRPr lang="th-TH"/>
          </a:p>
        </p:txBody>
      </p:sp>
      <p:sp>
        <p:nvSpPr>
          <p:cNvPr id="5" name="ตัวยึดท้ายกระดา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ยึดหมายเลขภาพนิ่ง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25DF7-5D81-48FB-88EB-F3941DF12C23}" type="slidenum">
              <a:rPr lang="th-TH" smtClean="0"/>
              <a:pPr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ชื่อเรื่องและเนื้อห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ลักษณะชื่อเรื่องต้นแบบ</a:t>
            </a:r>
          </a:p>
        </p:txBody>
      </p:sp>
      <p:sp>
        <p:nvSpPr>
          <p:cNvPr id="3" name="ตัวยึดเนื้อหา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h-TH"/>
              <a:t>คลิกเพื่อแก้ไขลักษณะ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ยึดวันที่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C7C2B-39D4-4C7E-AF8C-F2C3E9E03AE9}" type="datetimeFigureOut">
              <a:rPr lang="th-TH" smtClean="0"/>
              <a:pPr/>
              <a:t>19/10/64</a:t>
            </a:fld>
            <a:endParaRPr lang="th-TH"/>
          </a:p>
        </p:txBody>
      </p:sp>
      <p:sp>
        <p:nvSpPr>
          <p:cNvPr id="5" name="ตัวยึดท้ายกระดา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ยึดหมายเลขภาพนิ่ง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25DF7-5D81-48FB-88EB-F3941DF12C23}" type="slidenum">
              <a:rPr lang="th-TH" smtClean="0"/>
              <a:pPr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ส่วนหัวของ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th-TH"/>
              <a:t>คลิกเพื่อแก้ไขลักษณะชื่อเรื่องต้นแบบ</a:t>
            </a:r>
          </a:p>
        </p:txBody>
      </p:sp>
      <p:sp>
        <p:nvSpPr>
          <p:cNvPr id="3" name="ตัวยึดข้อความ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th-TH"/>
              <a:t>คลิกเพื่อแก้ไขลักษณะของข้อความต้นแบบ</a:t>
            </a:r>
          </a:p>
        </p:txBody>
      </p:sp>
      <p:sp>
        <p:nvSpPr>
          <p:cNvPr id="4" name="ตัวยึดวันที่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C7C2B-39D4-4C7E-AF8C-F2C3E9E03AE9}" type="datetimeFigureOut">
              <a:rPr lang="th-TH" smtClean="0"/>
              <a:pPr/>
              <a:t>19/10/64</a:t>
            </a:fld>
            <a:endParaRPr lang="th-TH"/>
          </a:p>
        </p:txBody>
      </p:sp>
      <p:sp>
        <p:nvSpPr>
          <p:cNvPr id="5" name="ตัวยึดท้ายกระดา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ยึดหมายเลขภาพนิ่ง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25DF7-5D81-48FB-88EB-F3941DF12C23}" type="slidenum">
              <a:rPr lang="th-TH" smtClean="0"/>
              <a:pPr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เนื้อหา 2 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ลักษณะชื่อเรื่องต้นแบบ</a:t>
            </a:r>
          </a:p>
        </p:txBody>
      </p:sp>
      <p:sp>
        <p:nvSpPr>
          <p:cNvPr id="3" name="ตัวยึดเนื้อหา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th-TH"/>
              <a:t>คลิกเพื่อแก้ไขลักษณะ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ยึดเนื้อหา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th-TH"/>
              <a:t>คลิกเพื่อแก้ไขลักษณะ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5" name="ตัวยึดวันที่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C7C2B-39D4-4C7E-AF8C-F2C3E9E03AE9}" type="datetimeFigureOut">
              <a:rPr lang="th-TH" smtClean="0"/>
              <a:pPr/>
              <a:t>19/10/64</a:t>
            </a:fld>
            <a:endParaRPr lang="th-TH"/>
          </a:p>
        </p:txBody>
      </p:sp>
      <p:sp>
        <p:nvSpPr>
          <p:cNvPr id="6" name="ตัวยึดท้ายกระดา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ยึดหมายเลขภาพนิ่ง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25DF7-5D81-48FB-88EB-F3941DF12C23}" type="slidenum">
              <a:rPr lang="th-TH" smtClean="0"/>
              <a:pPr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การเปรียบเทียบ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th-TH"/>
              <a:t>คลิกเพื่อแก้ไขลักษณะชื่อเรื่องต้นแบบ</a:t>
            </a:r>
          </a:p>
        </p:txBody>
      </p:sp>
      <p:sp>
        <p:nvSpPr>
          <p:cNvPr id="3" name="ตัวยึดข้อความ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/>
              <a:t>คลิกเพื่อแก้ไขลักษณะของข้อความต้นแบบ</a:t>
            </a:r>
          </a:p>
        </p:txBody>
      </p:sp>
      <p:sp>
        <p:nvSpPr>
          <p:cNvPr id="4" name="ตัวยึดเนื้อหา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th-TH"/>
              <a:t>คลิกเพื่อแก้ไขลักษณะ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5" name="ตัวยึดข้อความ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/>
              <a:t>คลิกเพื่อแก้ไขลักษณะของข้อความต้นแบบ</a:t>
            </a:r>
          </a:p>
        </p:txBody>
      </p:sp>
      <p:sp>
        <p:nvSpPr>
          <p:cNvPr id="6" name="ตัวยึดเนื้อหา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th-TH"/>
              <a:t>คลิกเพื่อแก้ไขลักษณะ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7" name="ตัวยึดวันที่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C7C2B-39D4-4C7E-AF8C-F2C3E9E03AE9}" type="datetimeFigureOut">
              <a:rPr lang="th-TH" smtClean="0"/>
              <a:pPr/>
              <a:t>19/10/64</a:t>
            </a:fld>
            <a:endParaRPr lang="th-TH"/>
          </a:p>
        </p:txBody>
      </p:sp>
      <p:sp>
        <p:nvSpPr>
          <p:cNvPr id="8" name="ตัวยึดท้ายกระดา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9" name="ตัวยึดหมายเลขภาพนิ่ง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25DF7-5D81-48FB-88EB-F3941DF12C23}" type="slidenum">
              <a:rPr lang="th-TH" smtClean="0"/>
              <a:pPr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เฉพาะ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ลักษณะชื่อเรื่องต้นแบบ</a:t>
            </a:r>
          </a:p>
        </p:txBody>
      </p:sp>
      <p:sp>
        <p:nvSpPr>
          <p:cNvPr id="3" name="ตัวยึดวันที่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C7C2B-39D4-4C7E-AF8C-F2C3E9E03AE9}" type="datetimeFigureOut">
              <a:rPr lang="th-TH" smtClean="0"/>
              <a:pPr/>
              <a:t>19/10/64</a:t>
            </a:fld>
            <a:endParaRPr lang="th-TH"/>
          </a:p>
        </p:txBody>
      </p:sp>
      <p:sp>
        <p:nvSpPr>
          <p:cNvPr id="4" name="ตัวยึดท้ายกระดา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5" name="ตัวยึดหมายเลขภาพนิ่ง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25DF7-5D81-48FB-88EB-F3941DF12C23}" type="slidenum">
              <a:rPr lang="th-TH" smtClean="0"/>
              <a:pPr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ว่างเปล่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ตัวยึดวันที่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C7C2B-39D4-4C7E-AF8C-F2C3E9E03AE9}" type="datetimeFigureOut">
              <a:rPr lang="th-TH" smtClean="0"/>
              <a:pPr/>
              <a:t>19/10/64</a:t>
            </a:fld>
            <a:endParaRPr lang="th-TH"/>
          </a:p>
        </p:txBody>
      </p:sp>
      <p:sp>
        <p:nvSpPr>
          <p:cNvPr id="3" name="ตัวยึดท้ายกระดา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4" name="ตัวยึดหมายเลขภาพนิ่ง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25DF7-5D81-48FB-88EB-F3941DF12C23}" type="slidenum">
              <a:rPr lang="th-TH" smtClean="0"/>
              <a:pPr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เนื้อหา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th-TH"/>
              <a:t>คลิกเพื่อแก้ไขลักษณะชื่อเรื่องต้นแบบ</a:t>
            </a:r>
          </a:p>
        </p:txBody>
      </p:sp>
      <p:sp>
        <p:nvSpPr>
          <p:cNvPr id="3" name="ตัวยึดเนื้อหา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h-TH"/>
              <a:t>คลิกเพื่อแก้ไขลักษณะ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ยึดข้อความ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th-TH"/>
              <a:t>คลิกเพื่อแก้ไขลักษณะของข้อความต้นแบบ</a:t>
            </a:r>
          </a:p>
        </p:txBody>
      </p:sp>
      <p:sp>
        <p:nvSpPr>
          <p:cNvPr id="5" name="ตัวยึดวันที่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C7C2B-39D4-4C7E-AF8C-F2C3E9E03AE9}" type="datetimeFigureOut">
              <a:rPr lang="th-TH" smtClean="0"/>
              <a:pPr/>
              <a:t>19/10/64</a:t>
            </a:fld>
            <a:endParaRPr lang="th-TH"/>
          </a:p>
        </p:txBody>
      </p:sp>
      <p:sp>
        <p:nvSpPr>
          <p:cNvPr id="6" name="ตัวยึดท้ายกระดา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ยึดหมายเลขภาพนิ่ง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25DF7-5D81-48FB-88EB-F3941DF12C23}" type="slidenum">
              <a:rPr lang="th-TH" smtClean="0"/>
              <a:pPr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รูปภาพ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th-TH"/>
              <a:t>คลิกเพื่อแก้ไขลักษณะชื่อเรื่องต้นแบบ</a:t>
            </a:r>
          </a:p>
        </p:txBody>
      </p:sp>
      <p:sp>
        <p:nvSpPr>
          <p:cNvPr id="3" name="ตัวยึดรูปภาพ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th-TH"/>
          </a:p>
        </p:txBody>
      </p:sp>
      <p:sp>
        <p:nvSpPr>
          <p:cNvPr id="4" name="ตัวยึดข้อความ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th-TH"/>
              <a:t>คลิกเพื่อแก้ไขลักษณะของข้อความต้นแบบ</a:t>
            </a:r>
          </a:p>
        </p:txBody>
      </p:sp>
      <p:sp>
        <p:nvSpPr>
          <p:cNvPr id="5" name="ตัวยึดวันที่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C7C2B-39D4-4C7E-AF8C-F2C3E9E03AE9}" type="datetimeFigureOut">
              <a:rPr lang="th-TH" smtClean="0"/>
              <a:pPr/>
              <a:t>19/10/64</a:t>
            </a:fld>
            <a:endParaRPr lang="th-TH"/>
          </a:p>
        </p:txBody>
      </p:sp>
      <p:sp>
        <p:nvSpPr>
          <p:cNvPr id="6" name="ตัวยึดท้ายกระดา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ยึดหมายเลขภาพนิ่ง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25DF7-5D81-48FB-88EB-F3941DF12C23}" type="slidenum">
              <a:rPr lang="th-TH" smtClean="0"/>
              <a:pPr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ตัวยึดชื่อเรื่อง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h-TH"/>
              <a:t>คลิกเพื่อแก้ไขลักษณะชื่อเรื่องต้นแบบ</a:t>
            </a:r>
          </a:p>
        </p:txBody>
      </p:sp>
      <p:sp>
        <p:nvSpPr>
          <p:cNvPr id="3" name="ตัวยึดข้อความ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h-TH"/>
              <a:t>คลิกเพื่อแก้ไขลักษณะ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ยึดวันที่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CC7C2B-39D4-4C7E-AF8C-F2C3E9E03AE9}" type="datetimeFigureOut">
              <a:rPr lang="th-TH" smtClean="0"/>
              <a:pPr/>
              <a:t>19/10/64</a:t>
            </a:fld>
            <a:endParaRPr lang="th-TH"/>
          </a:p>
        </p:txBody>
      </p:sp>
      <p:sp>
        <p:nvSpPr>
          <p:cNvPr id="5" name="ตัวยึดท้ายกระดาษ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h-TH"/>
          </a:p>
        </p:txBody>
      </p:sp>
      <p:sp>
        <p:nvSpPr>
          <p:cNvPr id="6" name="ตัวยึดหมายเลขภาพนิ่ง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925DF7-5D81-48FB-88EB-F3941DF12C23}" type="slidenum">
              <a:rPr lang="th-TH" smtClean="0"/>
              <a:pPr/>
              <a:t>‹#›</a:t>
            </a:fld>
            <a:endParaRPr lang="th-TH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h-TH"/>
      </a:defPPr>
      <a:lvl1pPr marL="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ตาราง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56143375"/>
              </p:ext>
            </p:extLst>
          </p:nvPr>
        </p:nvGraphicFramePr>
        <p:xfrm>
          <a:off x="1" y="919464"/>
          <a:ext cx="9143998" cy="5821904"/>
        </p:xfrm>
        <a:graphic>
          <a:graphicData uri="http://schemas.openxmlformats.org/drawingml/2006/table">
            <a:tbl>
              <a:tblPr/>
              <a:tblGrid>
                <a:gridCol w="254904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9575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4076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6870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39486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39486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13835"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Scientific name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ommon name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ccession number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ucleotide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mio acid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th-TH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13835">
                <a:tc vMerge="1">
                  <a:txBody>
                    <a:bodyPr/>
                    <a:lstStyle/>
                    <a:p>
                      <a:endParaRPr lang="th-TH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th-TH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th-TH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identity (%)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identity (%)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Similarity (%)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1383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Eukaryotic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1383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Vertebrate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1383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Homo sapiens hsp70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Human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M_002155  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2.1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7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77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1383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Homo sapiens  hsc70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Human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P_006588    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5.3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1.5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77.9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1383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Homo sapiens  grp78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Human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P_005338      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1.9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1.7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91.3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1383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us musculus  grp78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ouse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M_022310      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2.8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1.7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91.3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1383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Gallus gallus grp78 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hicken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P_990822.1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2.2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2.2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91.3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1383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Xenopus tropicalis grp78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Tropical clawed frog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XP_002941690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2.2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0.9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90.1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1383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anio rerio hsp70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Zebrafish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XM_003198110 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1.8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9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77.6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1383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anio rerio hsc70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Zebrafish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P_001103873  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4.8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0.5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77.3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1383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anio rerio grp78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Zebrafish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NM_213058  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1.5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2.5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90.8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1383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Paralichthys olivaceus grp78 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Japanese halibut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BG56392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3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2.9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90.7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1383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tenopharyngodon idella grp78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Grass Carp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CJ65009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1.5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2.5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90.5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1383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Invertebrate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296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err="1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Oxya</a:t>
                      </a:r>
                      <a:r>
                        <a:rPr lang="en-US" sz="800" i="1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</a:t>
                      </a:r>
                      <a:r>
                        <a:rPr lang="en-US" sz="800" i="1" dirty="0" err="1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hinensis</a:t>
                      </a:r>
                      <a:r>
                        <a:rPr lang="en-US" sz="800" i="1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grp78 </a:t>
                      </a:r>
                      <a:endParaRPr lang="en-US" sz="8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hinese Rice Grasshopper</a:t>
                      </a:r>
                      <a:endParaRPr lang="en-US" sz="8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FN08642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2.8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4.7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92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296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err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Eurytemora</a:t>
                      </a:r>
                      <a:r>
                        <a:rPr lang="en-US" sz="800" i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</a:t>
                      </a:r>
                      <a:r>
                        <a:rPr lang="en-US" sz="800" i="1" dirty="0" err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ffinis</a:t>
                      </a:r>
                      <a:r>
                        <a:rPr lang="en-US" sz="800" i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grp78 </a:t>
                      </a:r>
                      <a:endParaRPr lang="en-US" sz="8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opepod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EV42204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2.8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4.6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92.4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296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err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Litopenaeus</a:t>
                      </a:r>
                      <a:r>
                        <a:rPr lang="en-US" sz="800" i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</a:t>
                      </a:r>
                      <a:r>
                        <a:rPr lang="en-US" sz="800" i="1" dirty="0" err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vannamei</a:t>
                      </a:r>
                      <a:r>
                        <a:rPr lang="en-US" sz="800" i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grp78 </a:t>
                      </a:r>
                      <a:endParaRPr lang="en-US" sz="8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Pacific white shrimp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FQ62791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7.2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92.8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95.9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296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err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edes</a:t>
                      </a:r>
                      <a:r>
                        <a:rPr lang="en-US" sz="800" i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</a:t>
                      </a:r>
                      <a:r>
                        <a:rPr lang="en-US" sz="800" i="1" dirty="0" err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egypti</a:t>
                      </a:r>
                      <a:r>
                        <a:rPr lang="en-US" sz="800" i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grp78</a:t>
                      </a:r>
                      <a:endParaRPr lang="en-US" sz="8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Yollew head mosquito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Q440225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3.7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3.9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92.2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296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err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Polypedilum</a:t>
                      </a:r>
                      <a:r>
                        <a:rPr lang="en-US" sz="800" i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</a:t>
                      </a:r>
                      <a:r>
                        <a:rPr lang="en-US" sz="800" i="1" dirty="0" err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vanderplanki</a:t>
                      </a:r>
                      <a:r>
                        <a:rPr lang="en-US" sz="800" i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grp78</a:t>
                      </a:r>
                      <a:endParaRPr lang="en-US" sz="8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Sleeping chironomid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HM589531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4.6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5.3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93.6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296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err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Bombyx</a:t>
                      </a:r>
                      <a:r>
                        <a:rPr lang="en-US" sz="800" i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</a:t>
                      </a:r>
                      <a:r>
                        <a:rPr lang="en-US" sz="800" i="1" dirty="0" err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ori</a:t>
                      </a:r>
                      <a:r>
                        <a:rPr lang="en-US" sz="800" i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grp78</a:t>
                      </a:r>
                      <a:endParaRPr lang="en-US" sz="8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omesticated silkmoth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JF836796   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3.8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5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93.6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296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rosophila </a:t>
                      </a:r>
                      <a:r>
                        <a:rPr lang="en-US" sz="800" i="1" dirty="0" err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elanogaster</a:t>
                      </a:r>
                      <a:r>
                        <a:rPr lang="en-US" sz="800" i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(hsc70-1)   </a:t>
                      </a:r>
                      <a:endParaRPr lang="en-US" sz="8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Fruit fly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M_079339        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0.4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8.3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77.5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296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rosophila melanogaster (hsc70-3)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Fruit fly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M_167306  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3.1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4.4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92.5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296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rosophila </a:t>
                      </a:r>
                      <a:r>
                        <a:rPr lang="en-US" sz="800" i="1" dirty="0" err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elanogaster</a:t>
                      </a:r>
                      <a:r>
                        <a:rPr lang="en-US" sz="800" i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(hsc70-4)</a:t>
                      </a:r>
                      <a:endParaRPr lang="en-US" sz="8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Fruit fly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M_079632    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2.7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8.6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76.8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296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Fenneropenaeus chinensis hsc70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hinese white shrimp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Y748350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3.1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8.2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76.7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296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err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Fenneropenaeus</a:t>
                      </a:r>
                      <a:r>
                        <a:rPr lang="en-US" sz="800" i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</a:t>
                      </a:r>
                      <a:r>
                        <a:rPr lang="en-US" sz="800" i="1" dirty="0" err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hinensis</a:t>
                      </a:r>
                      <a:r>
                        <a:rPr lang="en-US" sz="800" i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hsp70</a:t>
                      </a:r>
                      <a:endParaRPr lang="en-US" sz="8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hinese white shrimp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FJ167398          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1.6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7.3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76.4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296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Fenneropenaeus chinensis grp78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hinese white shrimp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EF032651 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6.2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91.9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95.6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296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acrobrachium rosenbergii hsc70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Giant freshwater prawn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Y446497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49.9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1.9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8.5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296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acrobrachium rosenbergii hsp70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Giant freshwater prawn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Y466445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4.5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8.3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76.4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296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Plant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296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rabidopsis thaliana  hsp70</a:t>
                      </a:r>
                      <a:endParaRPr lang="en-US" sz="8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rabidopsis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M_120327     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4.4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1.3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77.3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296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rabidopsis thaliana (bip2)      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rabidopsis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M_180788 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6.7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6.3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2.6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1296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err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Gossypium</a:t>
                      </a:r>
                      <a:r>
                        <a:rPr lang="en-US" sz="800" i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</a:t>
                      </a:r>
                      <a:r>
                        <a:rPr lang="en-US" sz="800" i="1" dirty="0" err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hirsutum</a:t>
                      </a:r>
                      <a:r>
                        <a:rPr lang="en-US" sz="800" i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</a:t>
                      </a:r>
                      <a:r>
                        <a:rPr lang="en-US" sz="800" i="1" dirty="0" err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bip</a:t>
                      </a:r>
                      <a:r>
                        <a:rPr lang="en-US" sz="800" i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</a:t>
                      </a:r>
                      <a:endParaRPr lang="en-US" sz="8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exican cotton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CJ11746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8.6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9.4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4.5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1296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Fungi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1296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err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Saccharomyces</a:t>
                      </a:r>
                      <a:r>
                        <a:rPr lang="en-US" sz="800" i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</a:t>
                      </a:r>
                      <a:r>
                        <a:rPr lang="en-US" sz="800" i="1" dirty="0" err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erevisiae</a:t>
                      </a:r>
                      <a:r>
                        <a:rPr lang="en-US" sz="800" i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</a:t>
                      </a:r>
                      <a:r>
                        <a:rPr lang="en-US" sz="8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S288c  </a:t>
                      </a:r>
                      <a:endParaRPr lang="en-US" sz="8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Yeast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M_001181468 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8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5.2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79.3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1296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err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agnaporthe</a:t>
                      </a:r>
                      <a:r>
                        <a:rPr lang="en-US" sz="800" i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</a:t>
                      </a:r>
                      <a:r>
                        <a:rPr lang="en-US" sz="800" i="1" dirty="0" err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oryzae</a:t>
                      </a:r>
                      <a:r>
                        <a:rPr lang="en-US" sz="800" i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</a:t>
                      </a:r>
                      <a:endParaRPr lang="en-US" sz="8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Rice blast fungus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XM_003709260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6.3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7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1.7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1296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Protozoa</a:t>
                      </a:r>
                      <a:endParaRPr lang="en-US" sz="8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1296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err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Theileria</a:t>
                      </a:r>
                      <a:r>
                        <a:rPr lang="en-US" sz="800" i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</a:t>
                      </a:r>
                      <a:r>
                        <a:rPr lang="en-US" sz="800" i="1" dirty="0" err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parva</a:t>
                      </a:r>
                      <a:r>
                        <a:rPr lang="en-US" sz="8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strain </a:t>
                      </a:r>
                      <a:r>
                        <a:rPr lang="en-US" sz="800" dirty="0" err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uguga</a:t>
                      </a:r>
                      <a:r>
                        <a:rPr lang="en-US" sz="800" i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</a:t>
                      </a:r>
                      <a:endParaRPr lang="en-US" sz="8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Theileria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XM_759226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4.4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7.7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77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1296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ictyostelium discoideum </a:t>
                      </a: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X4  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Soil-living amoeba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XM_638063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6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5.1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1.7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1296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cytostelium subglobosum 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cytostelium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ER57864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5.6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7.2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3.1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  <a:tr h="1296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Prokaryotic</a:t>
                      </a:r>
                      <a:endParaRPr lang="en-US" sz="8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1"/>
                  </a:ext>
                </a:extLst>
              </a:tr>
              <a:tr h="1296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lostridium acetobutylicum  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lostridium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74569.1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1.6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49.3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7.1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2"/>
                  </a:ext>
                </a:extLst>
              </a:tr>
              <a:tr h="1296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err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Bartonella</a:t>
                      </a:r>
                      <a:r>
                        <a:rPr lang="en-US" sz="800" i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</a:t>
                      </a:r>
                      <a:r>
                        <a:rPr lang="en-US" sz="800" i="1" dirty="0" err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henselae</a:t>
                      </a:r>
                      <a:endParaRPr lang="en-US" sz="8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Bartonella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DO46095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2.1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1.5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70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3"/>
                  </a:ext>
                </a:extLst>
              </a:tr>
              <a:tr h="12960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i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Escherichia coli </a:t>
                      </a:r>
                      <a:endParaRPr lang="en-US" sz="8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E. coli 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KGI46578.1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49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47.6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8.7</a:t>
                      </a:r>
                      <a:endParaRPr lang="en-US" sz="8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972" marR="3297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4"/>
                  </a:ext>
                </a:extLst>
              </a:tr>
            </a:tbl>
          </a:graphicData>
        </a:graphic>
      </p:graphicFrame>
      <p:sp>
        <p:nvSpPr>
          <p:cNvPr id="62465" name="Text Box 1"/>
          <p:cNvSpPr txBox="1">
            <a:spLocks noChangeArrowheads="1"/>
          </p:cNvSpPr>
          <p:nvPr/>
        </p:nvSpPr>
        <p:spPr bwMode="auto">
          <a:xfrm>
            <a:off x="-15875" y="1116316"/>
            <a:ext cx="2338388" cy="4524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th-TH" sz="2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-35845" y="6811406"/>
            <a:ext cx="673224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2000" b="1" dirty="0">
                <a:latin typeface="Times New Roman" charset="0"/>
                <a:ea typeface="Times New Roman" charset="0"/>
                <a:cs typeface="Times New Roman" charset="0"/>
              </a:rPr>
              <a:t>Supplement material Table S1</a:t>
            </a:r>
            <a:r>
              <a:rPr lang="th-TH" sz="2000" b="1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sz="2000" b="1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sz="2000" b="1" dirty="0" err="1">
                <a:latin typeface="Times New Roman" charset="0"/>
                <a:ea typeface="Times New Roman" charset="0"/>
                <a:cs typeface="Times New Roman" charset="0"/>
              </a:rPr>
              <a:t>Srisapoome</a:t>
            </a:r>
            <a:r>
              <a:rPr lang="en-US" sz="2000" b="1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sz="2000" b="1" i="1" dirty="0">
                <a:latin typeface="Times New Roman" charset="0"/>
                <a:ea typeface="Times New Roman" charset="0"/>
                <a:cs typeface="Times New Roman" charset="0"/>
              </a:rPr>
              <a:t>et al</a:t>
            </a:r>
            <a:r>
              <a:rPr lang="en-US" sz="2000" b="1" dirty="0">
                <a:latin typeface="Times New Roman" charset="0"/>
                <a:ea typeface="Times New Roman" charset="0"/>
                <a:cs typeface="Times New Roman" charset="0"/>
              </a:rPr>
              <a:t>. (2021)</a:t>
            </a:r>
            <a:endParaRPr lang="en-US" sz="3600" b="1" dirty="0">
              <a:latin typeface="Times New Roman" charset="0"/>
              <a:ea typeface="Times New Roman" charset="0"/>
              <a:cs typeface="Times New Roman" charset="0"/>
            </a:endParaRPr>
          </a:p>
          <a:p>
            <a:r>
              <a:rPr lang="en-US" sz="2000" b="1" dirty="0">
                <a:latin typeface="Times New Roman" charset="0"/>
                <a:ea typeface="Times New Roman" charset="0"/>
                <a:cs typeface="Times New Roman" charset="0"/>
              </a:rPr>
              <a:t>  </a:t>
            </a:r>
            <a:endParaRPr lang="th-TH" sz="20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A87E494-5DB7-3C42-91AF-74A9D97D13C6}"/>
              </a:ext>
            </a:extLst>
          </p:cNvPr>
          <p:cNvSpPr txBox="1"/>
          <p:nvPr/>
        </p:nvSpPr>
        <p:spPr>
          <a:xfrm>
            <a:off x="17259" y="26546"/>
            <a:ext cx="912674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1600" b="1" dirty="0">
                <a:latin typeface="Palatino Linotype" panose="02040502050505030304" pitchFamily="18" charset="0"/>
                <a:ea typeface="Times New Roman" charset="0"/>
                <a:cs typeface="Times New Roman" charset="0"/>
              </a:rPr>
              <a:t>Supplement material Table S1. </a:t>
            </a:r>
            <a:r>
              <a:rPr lang="en-US" sz="1400" dirty="0">
                <a:latin typeface="Palatino Linotype" panose="02040502050505030304" pitchFamily="18" charset="0"/>
                <a:ea typeface="Times New Roman" charset="0"/>
                <a:cs typeface="Times New Roman" charset="0"/>
              </a:rPr>
              <a:t>The nucleotide and amino acid sequence comparisons of Mr-grp78 against other known Hsp70s of organisms. GenBank accession numbers of the analyzed Hsp70 of each organism are indicated next to their scientific and common names, respectively. </a:t>
            </a:r>
            <a:endParaRPr lang="th-TH" sz="1600" dirty="0">
              <a:latin typeface="Palatino Linotype" panose="02040502050505030304" pitchFamily="18" charset="0"/>
              <a:ea typeface="Times New Roman" charset="0"/>
              <a:cs typeface="Times New Roman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ชุดรูปแบบของ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ชุดรูปแบบของ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14</TotalTime>
  <Words>476</Words>
  <Application>Microsoft Office PowerPoint</Application>
  <PresentationFormat>On-screen Show (4:3)</PresentationFormat>
  <Paragraphs>26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ngsana New</vt:lpstr>
      <vt:lpstr>Arial</vt:lpstr>
      <vt:lpstr>Calibri</vt:lpstr>
      <vt:lpstr>Cordia New</vt:lpstr>
      <vt:lpstr>Palatino Linotype</vt:lpstr>
      <vt:lpstr>Times New Roman</vt:lpstr>
      <vt:lpstr>ชุดรูปแบบของ Office</vt:lpstr>
      <vt:lpstr>PowerPoint Presentation</vt:lpstr>
    </vt:vector>
  </TitlesOfParts>
  <Company>Service 99-99-9999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รูป Characterization and Expression Analysis of cDNAs Encoding Heat Shock Protein 40 ,90  and Glucose Regulated Protein 78 Genes  of Giant Freshwater Prawn  (Macrobrachium rosenbergii)</dc:title>
  <dc:creator>Mr.Robin ThaiSakon</dc:creator>
  <cp:lastModifiedBy>MDPI</cp:lastModifiedBy>
  <cp:revision>25</cp:revision>
  <dcterms:created xsi:type="dcterms:W3CDTF">2017-02-24T04:39:57Z</dcterms:created>
  <dcterms:modified xsi:type="dcterms:W3CDTF">2021-10-19T02:31:32Z</dcterms:modified>
</cp:coreProperties>
</file>